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1" r:id="rId3"/>
    <p:sldId id="272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30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197835C-1564-4719-B420-69F9CE93901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FB407C1-61A5-4DCE-9EC0-A3409517702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605269-7493-46BF-9D77-02FCD29692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E73B8-9DBD-403C-8E55-06A0BE8DBFFD}" type="datetimeFigureOut">
              <a:rPr lang="zh-CN" altLang="en-US" smtClean="0"/>
              <a:t>2021/3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353B4F0-BF14-4E27-B315-CA3B2AB9E6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271CF06-7BC2-48B1-AA6D-B9D0D1B7C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40963-0836-43D2-B8CB-75A1B4D3E4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9289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337DD41-9802-4D0E-AD5B-3FAC478DE3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FADB130-C6C1-45F5-BDEB-95B42EA2E0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EA2288A-AF31-44DD-A800-EA6A8C0A7D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E73B8-9DBD-403C-8E55-06A0BE8DBFFD}" type="datetimeFigureOut">
              <a:rPr lang="zh-CN" altLang="en-US" smtClean="0"/>
              <a:t>2021/3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75872E6-B527-498F-857B-F69F38E811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C58400D-9C54-40BF-BA38-88A7BF8EB1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40963-0836-43D2-B8CB-75A1B4D3E4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19826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1F5D84E-19BC-4F62-A3BC-9FBD0EDDB3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CFF5210-7E80-4D2D-AD0B-EFE974F232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5DDCBB2-F49A-4D8E-B0B0-429C8FABC0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E73B8-9DBD-403C-8E55-06A0BE8DBFFD}" type="datetimeFigureOut">
              <a:rPr lang="zh-CN" altLang="en-US" smtClean="0"/>
              <a:t>2021/3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AED1455-F4E2-4E66-AD3D-7C08FABC7E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1C3400E-BD26-47FB-B3DC-FB0C46F6D8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40963-0836-43D2-B8CB-75A1B4D3E4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639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3B7F72-E993-4CCE-960C-8C65ACEBDF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F8432A7-FD7D-43A5-9BD7-3C2013535B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1182874-3B7A-4656-867B-8837DD68AE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E73B8-9DBD-403C-8E55-06A0BE8DBFFD}" type="datetimeFigureOut">
              <a:rPr lang="zh-CN" altLang="en-US" smtClean="0"/>
              <a:t>2021/3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05E766-8F89-43AE-89A5-CE053720DE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C5F34E9-675E-43DC-ADFB-39507938FE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40963-0836-43D2-B8CB-75A1B4D3E4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4296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676B4A-8AC7-4F3F-90FD-B1DD7CDDFA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19CD1DB-169B-473F-93DD-9A54BB24C9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D1F5065-272D-414E-9152-C00C6D6E25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E73B8-9DBD-403C-8E55-06A0BE8DBFFD}" type="datetimeFigureOut">
              <a:rPr lang="zh-CN" altLang="en-US" smtClean="0"/>
              <a:t>2021/3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2A85F0D-BAC1-4274-BE2A-7407A9C2BF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D00BC3A-061E-41E1-B0EB-FEBA25A144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40963-0836-43D2-B8CB-75A1B4D3E4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38744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7DF415A-DCB0-41C2-AF9A-5B7C1F7CEB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5C223EE-1376-48F6-9867-2B7752483CC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61A717D-2BE2-4895-81EB-C2E0B95CB9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B87E5E7-CC7D-4A32-AD92-122FF1F69C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E73B8-9DBD-403C-8E55-06A0BE8DBFFD}" type="datetimeFigureOut">
              <a:rPr lang="zh-CN" altLang="en-US" smtClean="0"/>
              <a:t>2021/3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129C4A1-173D-49C1-9429-69F308F3AB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9A47BA5-F546-4097-B160-8A9553E3C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40963-0836-43D2-B8CB-75A1B4D3E4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9079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0311B9F-D715-45AB-9A4D-3B2B3DCF91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17E8CDC-1E70-42EE-82E1-AF7CE7231C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DC30CCD-2D44-4F0B-8131-116ACB0414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AC34CC9-95E3-48D9-B98F-2DC594846AE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31822C8-8B22-4715-823A-81BE3A56D58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7997872-E6CE-4651-8A02-A363934D60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E73B8-9DBD-403C-8E55-06A0BE8DBFFD}" type="datetimeFigureOut">
              <a:rPr lang="zh-CN" altLang="en-US" smtClean="0"/>
              <a:t>2021/3/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9018A48-3FDB-4092-8E52-B2FDD47F20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40B463C-0430-4688-A800-B4F2E8451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40963-0836-43D2-B8CB-75A1B4D3E4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7846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83D4FF3-DDAC-4884-9E6F-9551AB850D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85A85BA-4983-4553-83AC-F2228B5340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E73B8-9DBD-403C-8E55-06A0BE8DBFFD}" type="datetimeFigureOut">
              <a:rPr lang="zh-CN" altLang="en-US" smtClean="0"/>
              <a:t>2021/3/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D575488-6BB5-4B4E-9C03-452F290B65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E4777DE-9FFF-4BCE-9682-BC52C8FEEA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40963-0836-43D2-B8CB-75A1B4D3E4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2311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F9D6143-76A6-4B2A-BB11-D84BE7A398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E73B8-9DBD-403C-8E55-06A0BE8DBFFD}" type="datetimeFigureOut">
              <a:rPr lang="zh-CN" altLang="en-US" smtClean="0"/>
              <a:t>2021/3/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E7DA711-E210-4687-884E-EC0A340495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D611C0F-C5FD-48BF-B78F-72A6AE47ED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40963-0836-43D2-B8CB-75A1B4D3E4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08481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695803-F946-4373-95ED-987C81B873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42422D0-4F6E-4DC8-91B1-3BE1E878B31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6B0B563-FA0D-4691-9CEB-AC25BAD7A8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CE0DB77-D83C-4D5D-8219-2DAF6EA1F2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E73B8-9DBD-403C-8E55-06A0BE8DBFFD}" type="datetimeFigureOut">
              <a:rPr lang="zh-CN" altLang="en-US" smtClean="0"/>
              <a:t>2021/3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D8CB11D-7086-4B0D-8CBC-A66EED96A8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7C8EF67-91ED-425D-A8BA-2143CBB440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40963-0836-43D2-B8CB-75A1B4D3E4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067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2B5F2F3-52C1-4B5D-8E90-6DFE14B710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188C0F1-EF81-43BF-95CB-D43C396430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88F2D75-88D2-4FB1-AAF3-0A8E71CFFD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B66D97B-65B0-498F-B420-7AC6E6BB75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E73B8-9DBD-403C-8E55-06A0BE8DBFFD}" type="datetimeFigureOut">
              <a:rPr lang="zh-CN" altLang="en-US" smtClean="0"/>
              <a:t>2021/3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17B8AC8-21C9-4759-9D1A-57A6EF7762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440E76B-7C7A-4FE4-B543-61C33A076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40963-0836-43D2-B8CB-75A1B4D3E4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0629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B2C841B-5C69-45F2-BE8D-8B97A41116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D81D061-9CEF-4447-996A-A68AF700C0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24E4103-A631-4F81-A81A-39D45A2EB26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5E73B8-9DBD-403C-8E55-06A0BE8DBFFD}" type="datetimeFigureOut">
              <a:rPr lang="zh-CN" altLang="en-US" smtClean="0"/>
              <a:t>2021/3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7354782-F389-4744-BDAD-5C16B9F38C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1A88B73-502E-41C6-8DFF-393D9A38BC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F40963-0836-43D2-B8CB-75A1B4D3E4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0201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E6307B4-8C3C-43E4-B062-6616163478D2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CN" dirty="0"/>
              <a:t>WB result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7409579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EB78A07-9423-4BC9-9C83-BA4C9C1D8D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0792D-C382-4E5F-8BC5-396551C8EB66}" type="slidenum">
              <a:rPr lang="zh-CN" altLang="en-US" b="1">
                <a:latin typeface="Times New Roman" panose="02020603050405020304" pitchFamily="18" charset="0"/>
                <a:cs typeface="Times New Roman" panose="02020603050405020304" pitchFamily="18" charset="0"/>
              </a:rPr>
              <a:pPr/>
              <a:t>2</a:t>
            </a:fld>
            <a:endParaRPr lang="zh-CN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314" name="图片 1" descr="webwxgetmsgimg">
            <a:extLst>
              <a:ext uri="{FF2B5EF4-FFF2-40B4-BE49-F238E27FC236}">
                <a16:creationId xmlns:a16="http://schemas.microsoft.com/office/drawing/2014/main" id="{10D8678E-DCAC-48D4-9A4D-E370EBB800C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59" t="45309" r="11293" b="40997"/>
          <a:stretch>
            <a:fillRect/>
          </a:stretch>
        </p:blipFill>
        <p:spPr bwMode="auto">
          <a:xfrm>
            <a:off x="4658910" y="946009"/>
            <a:ext cx="5019675" cy="2022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317" name="文本框 5">
            <a:extLst>
              <a:ext uri="{FF2B5EF4-FFF2-40B4-BE49-F238E27FC236}">
                <a16:creationId xmlns:a16="http://schemas.microsoft.com/office/drawing/2014/main" id="{4D80589E-A107-4B70-9F42-0F09FBE239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4300" y="765175"/>
            <a:ext cx="309155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    Rapa    2.5   5     10</a:t>
            </a:r>
          </a:p>
        </p:txBody>
      </p:sp>
      <p:sp>
        <p:nvSpPr>
          <p:cNvPr id="13318" name="文本框 6">
            <a:extLst>
              <a:ext uri="{FF2B5EF4-FFF2-40B4-BE49-F238E27FC236}">
                <a16:creationId xmlns:a16="http://schemas.microsoft.com/office/drawing/2014/main" id="{CE424DC8-7C12-4DA2-AD5D-CAC65704FB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73519" y="1451353"/>
            <a:ext cx="870751" cy="31393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3I</a:t>
            </a:r>
          </a:p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3II</a:t>
            </a:r>
          </a:p>
          <a:p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2</a:t>
            </a:r>
          </a:p>
          <a:p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</a:p>
        </p:txBody>
      </p:sp>
      <p:sp>
        <p:nvSpPr>
          <p:cNvPr id="13319" name="文本框 7">
            <a:extLst>
              <a:ext uri="{FF2B5EF4-FFF2-40B4-BE49-F238E27FC236}">
                <a16:creationId xmlns:a16="http://schemas.microsoft.com/office/drawing/2014/main" id="{6F673CAE-853B-4342-8D45-24601601B5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95451" y="5658783"/>
            <a:ext cx="7653338" cy="9233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e: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sult shown in the main text only included the blot data of  Control, 2.5 </a:t>
            </a:r>
            <a:r>
              <a:rPr lang="el-GR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, and 5 </a:t>
            </a:r>
            <a:r>
              <a:rPr lang="el-GR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 LNO. The Rapa group (positive control) and 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the 10 </a:t>
            </a:r>
            <a:r>
              <a:rPr lang="el-GR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 LNO group were cropped. We updated the result in the revision.</a:t>
            </a:r>
          </a:p>
        </p:txBody>
      </p:sp>
      <p:sp>
        <p:nvSpPr>
          <p:cNvPr id="13320" name="文本框 8">
            <a:extLst>
              <a:ext uri="{FF2B5EF4-FFF2-40B4-BE49-F238E27FC236}">
                <a16:creationId xmlns:a16="http://schemas.microsoft.com/office/drawing/2014/main" id="{AA9F004D-30E2-44F0-B3A3-76461EA2A1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28048" y="740936"/>
            <a:ext cx="84350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µ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</a:t>
            </a: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C584F28C-DD9C-4D26-96D7-E662D305B92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28" t="54390" r="4596" b="14547"/>
          <a:stretch/>
        </p:blipFill>
        <p:spPr>
          <a:xfrm rot="218858">
            <a:off x="4912087" y="2684455"/>
            <a:ext cx="5227425" cy="1275815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AF903398-264E-4387-93DE-12CC72F5600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45" t="44213" r="-4051" b="9412"/>
          <a:stretch/>
        </p:blipFill>
        <p:spPr>
          <a:xfrm>
            <a:off x="4973176" y="3884652"/>
            <a:ext cx="4676503" cy="1520589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18">
            <a:extLst>
              <a:ext uri="{FF2B5EF4-FFF2-40B4-BE49-F238E27FC236}">
                <a16:creationId xmlns:a16="http://schemas.microsoft.com/office/drawing/2014/main" id="{0A831FDF-37E0-4CED-9C29-FB80CF396ED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73" t="7563" r="500" b="-347"/>
          <a:stretch/>
        </p:blipFill>
        <p:spPr bwMode="auto">
          <a:xfrm>
            <a:off x="3080255" y="1015925"/>
            <a:ext cx="5422867" cy="30384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5352800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0</TotalTime>
  <Words>72</Words>
  <Application>Microsoft Office PowerPoint</Application>
  <PresentationFormat>宽屏</PresentationFormat>
  <Paragraphs>16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WB results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Nano-dawn</dc:creator>
  <cp:lastModifiedBy>Nano-dawn</cp:lastModifiedBy>
  <cp:revision>6</cp:revision>
  <dcterms:created xsi:type="dcterms:W3CDTF">2021-03-05T07:13:23Z</dcterms:created>
  <dcterms:modified xsi:type="dcterms:W3CDTF">2021-03-05T23:18:08Z</dcterms:modified>
</cp:coreProperties>
</file>